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60" r:id="rId2"/>
  </p:sldIdLst>
  <p:sldSz cx="6858000" cy="9144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1"/>
    <p:restoredTop sz="77000" autoAdjust="0"/>
  </p:normalViewPr>
  <p:slideViewPr>
    <p:cSldViewPr snapToGrid="0" snapToObjects="1">
      <p:cViewPr varScale="1">
        <p:scale>
          <a:sx n="62" d="100"/>
          <a:sy n="62" d="100"/>
        </p:scale>
        <p:origin x="-1872" y="-9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18" Type="http://schemas.microsoft.com/office/2015/10/relationships/revisionInfo" Target="revisionInfo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B1FB776-10CD-FB47-94DC-710F9875BE93}" type="datetimeFigureOut">
              <a:rPr lang="en-US" smtClean="0"/>
              <a:t>1/15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F5DAEED-EE94-604F-9056-72416A5855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91915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Supplemental 3: ONC201 and combination with </a:t>
            </a: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evacizumab </a:t>
            </a:r>
            <a:r>
              <a:rPr lang="en-US" b="1" dirty="0"/>
              <a:t> are non toxic in vivo. </a:t>
            </a:r>
            <a:r>
              <a:rPr lang="en-US" b="0" dirty="0"/>
              <a:t>Blood chemistry panel results from mice treated with indicated drugs. Blood was collected by cardiac puncture at end of experiment. ONC201 50mg/kg weekly.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evacizumab </a:t>
            </a:r>
            <a:r>
              <a:rPr lang="en-US" altLang="en-US" dirty="0"/>
              <a:t> is 5mg/kg every 2 weeks. Regorafenib: 5mg/kg daily. N=3. </a:t>
            </a:r>
            <a:endParaRPr lang="en-US" b="1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234B4C1-4FF2-4F6E-AD9F-C3425F53B084}" type="slidenum">
              <a:rPr lang="en-US" smtClean="0"/>
              <a:t>1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7000895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515B7B-69FE-D941-9EAE-512165C8B66C}" type="datetimeFigureOut">
              <a:rPr lang="en-US" smtClean="0"/>
              <a:t>1/1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6592CB-360B-4F44-892B-C72929B45EC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515B7B-69FE-D941-9EAE-512165C8B66C}" type="datetimeFigureOut">
              <a:rPr lang="en-US" smtClean="0"/>
              <a:t>1/1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6592CB-360B-4F44-892B-C72929B45EC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515B7B-69FE-D941-9EAE-512165C8B66C}" type="datetimeFigureOut">
              <a:rPr lang="en-US" smtClean="0"/>
              <a:t>1/1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6592CB-360B-4F44-892B-C72929B45EC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515B7B-69FE-D941-9EAE-512165C8B66C}" type="datetimeFigureOut">
              <a:rPr lang="en-US" smtClean="0"/>
              <a:t>1/1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6592CB-360B-4F44-892B-C72929B45EC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515B7B-69FE-D941-9EAE-512165C8B66C}" type="datetimeFigureOut">
              <a:rPr lang="en-US" smtClean="0"/>
              <a:t>1/1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6592CB-360B-4F44-892B-C72929B45EC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515B7B-69FE-D941-9EAE-512165C8B66C}" type="datetimeFigureOut">
              <a:rPr lang="en-US" smtClean="0"/>
              <a:t>1/15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6592CB-360B-4F44-892B-C72929B45EC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515B7B-69FE-D941-9EAE-512165C8B66C}" type="datetimeFigureOut">
              <a:rPr lang="en-US" smtClean="0"/>
              <a:t>1/15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6592CB-360B-4F44-892B-C72929B45EC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515B7B-69FE-D941-9EAE-512165C8B66C}" type="datetimeFigureOut">
              <a:rPr lang="en-US" smtClean="0"/>
              <a:t>1/15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6592CB-360B-4F44-892B-C72929B45EC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515B7B-69FE-D941-9EAE-512165C8B66C}" type="datetimeFigureOut">
              <a:rPr lang="en-US" smtClean="0"/>
              <a:t>1/15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6592CB-360B-4F44-892B-C72929B45EC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515B7B-69FE-D941-9EAE-512165C8B66C}" type="datetimeFigureOut">
              <a:rPr lang="en-US" smtClean="0"/>
              <a:t>1/15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6592CB-360B-4F44-892B-C72929B45EC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515B7B-69FE-D941-9EAE-512165C8B66C}" type="datetimeFigureOut">
              <a:rPr lang="en-US" smtClean="0"/>
              <a:t>1/15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6592CB-360B-4F44-892B-C72929B45EC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515B7B-69FE-D941-9EAE-512165C8B66C}" type="datetimeFigureOut">
              <a:rPr lang="en-US" smtClean="0"/>
              <a:t>1/1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6592CB-360B-4F44-892B-C72929B45E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06382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8BE3095B-9FEC-40D8-847E-C8982DDFA0E3}"/>
              </a:ext>
            </a:extLst>
          </p:cNvPr>
          <p:cNvSpPr txBox="1"/>
          <p:nvPr/>
        </p:nvSpPr>
        <p:spPr>
          <a:xfrm>
            <a:off x="0" y="8686453"/>
            <a:ext cx="40233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Wagner </a:t>
            </a:r>
            <a:r>
              <a:rPr lang="en-US" b="1" i="1" dirty="0"/>
              <a:t>et al</a:t>
            </a:r>
            <a:r>
              <a:rPr lang="en-US" b="1" dirty="0"/>
              <a:t>., Supplemental Figure 3</a:t>
            </a:r>
          </a:p>
        </p:txBody>
      </p:sp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xmlns="" id="{B44821E8-B11D-4682-AF6B-739027BED1E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50098562"/>
              </p:ext>
            </p:extLst>
          </p:nvPr>
        </p:nvGraphicFramePr>
        <p:xfrm>
          <a:off x="105128" y="437198"/>
          <a:ext cx="6752874" cy="7899199"/>
        </p:xfrm>
        <a:graphic>
          <a:graphicData uri="http://schemas.openxmlformats.org/drawingml/2006/table">
            <a:tbl>
              <a:tblPr/>
              <a:tblGrid>
                <a:gridCol w="1439142">
                  <a:extLst>
                    <a:ext uri="{9D8B030D-6E8A-4147-A177-3AD203B41FA5}">
                      <a16:colId xmlns:a16="http://schemas.microsoft.com/office/drawing/2014/main" xmlns="" val="2114751251"/>
                    </a:ext>
                  </a:extLst>
                </a:gridCol>
                <a:gridCol w="885622">
                  <a:extLst>
                    <a:ext uri="{9D8B030D-6E8A-4147-A177-3AD203B41FA5}">
                      <a16:colId xmlns:a16="http://schemas.microsoft.com/office/drawing/2014/main" xmlns="" val="1282933484"/>
                    </a:ext>
                  </a:extLst>
                </a:gridCol>
                <a:gridCol w="885622">
                  <a:extLst>
                    <a:ext uri="{9D8B030D-6E8A-4147-A177-3AD203B41FA5}">
                      <a16:colId xmlns:a16="http://schemas.microsoft.com/office/drawing/2014/main" xmlns="" val="3479694757"/>
                    </a:ext>
                  </a:extLst>
                </a:gridCol>
                <a:gridCol w="885622">
                  <a:extLst>
                    <a:ext uri="{9D8B030D-6E8A-4147-A177-3AD203B41FA5}">
                      <a16:colId xmlns:a16="http://schemas.microsoft.com/office/drawing/2014/main" xmlns="" val="3384777179"/>
                    </a:ext>
                  </a:extLst>
                </a:gridCol>
                <a:gridCol w="885622">
                  <a:extLst>
                    <a:ext uri="{9D8B030D-6E8A-4147-A177-3AD203B41FA5}">
                      <a16:colId xmlns:a16="http://schemas.microsoft.com/office/drawing/2014/main" xmlns="" val="2527084214"/>
                    </a:ext>
                  </a:extLst>
                </a:gridCol>
                <a:gridCol w="885622">
                  <a:extLst>
                    <a:ext uri="{9D8B030D-6E8A-4147-A177-3AD203B41FA5}">
                      <a16:colId xmlns:a16="http://schemas.microsoft.com/office/drawing/2014/main" xmlns="" val="1328631260"/>
                    </a:ext>
                  </a:extLst>
                </a:gridCol>
                <a:gridCol w="885622">
                  <a:extLst>
                    <a:ext uri="{9D8B030D-6E8A-4147-A177-3AD203B41FA5}">
                      <a16:colId xmlns:a16="http://schemas.microsoft.com/office/drawing/2014/main" xmlns="" val="707433546"/>
                    </a:ext>
                  </a:extLst>
                </a:gridCol>
              </a:tblGrid>
              <a:tr h="222460">
                <a:tc>
                  <a:txBody>
                    <a:bodyPr/>
                    <a:lstStyle/>
                    <a:p>
                      <a:pPr algn="l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reatine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ucose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LT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ST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LP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511628446"/>
                  </a:ext>
                </a:extLst>
              </a:tr>
              <a:tr h="119257">
                <a:tc>
                  <a:txBody>
                    <a:bodyPr/>
                    <a:lstStyle/>
                    <a:p>
                      <a:pPr algn="l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ehicle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7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5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2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15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5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561986966"/>
                  </a:ext>
                </a:extLst>
              </a:tr>
              <a:tr h="119257">
                <a:tc>
                  <a:txBody>
                    <a:bodyPr/>
                    <a:lstStyle/>
                    <a:p>
                      <a:pPr algn="l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ehicle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1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6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7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8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0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829787160"/>
                  </a:ext>
                </a:extLst>
              </a:tr>
              <a:tr h="119257">
                <a:tc>
                  <a:txBody>
                    <a:bodyPr/>
                    <a:lstStyle/>
                    <a:p>
                      <a:pPr algn="l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ehicle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9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7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1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12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5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941470105"/>
                  </a:ext>
                </a:extLst>
              </a:tr>
              <a:tr h="332544">
                <a:tc>
                  <a:txBody>
                    <a:bodyPr/>
                    <a:lstStyle/>
                    <a:p>
                      <a:pPr algn="l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NC201 50/1wk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3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8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6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5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1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749304665"/>
                  </a:ext>
                </a:extLst>
              </a:tr>
              <a:tr h="332544">
                <a:tc>
                  <a:txBody>
                    <a:bodyPr/>
                    <a:lstStyle/>
                    <a:p>
                      <a:pPr algn="l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NC201 50/1wk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0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7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4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15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1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108481735"/>
                  </a:ext>
                </a:extLst>
              </a:tr>
              <a:tr h="332544">
                <a:tc>
                  <a:txBody>
                    <a:bodyPr/>
                    <a:lstStyle/>
                    <a:p>
                      <a:pPr algn="l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NC201 50/1wk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1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0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0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9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6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917388022"/>
                  </a:ext>
                </a:extLst>
              </a:tr>
              <a:tr h="222460">
                <a:tc>
                  <a:txBody>
                    <a:bodyPr/>
                    <a:lstStyle/>
                    <a:p>
                      <a:pPr algn="l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evacizumab 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9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9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2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5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5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564976379"/>
                  </a:ext>
                </a:extLst>
              </a:tr>
              <a:tr h="222460">
                <a:tc>
                  <a:txBody>
                    <a:bodyPr/>
                    <a:lstStyle/>
                    <a:p>
                      <a:pPr algn="l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evacizumab 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1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5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1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13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2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789710267"/>
                  </a:ext>
                </a:extLst>
              </a:tr>
              <a:tr h="222460">
                <a:tc>
                  <a:txBody>
                    <a:bodyPr/>
                    <a:lstStyle/>
                    <a:p>
                      <a:pPr algn="l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evacizumab 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7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6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6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9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8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256648440"/>
                  </a:ext>
                </a:extLst>
              </a:tr>
              <a:tr h="332544">
                <a:tc>
                  <a:txBody>
                    <a:bodyPr/>
                    <a:lstStyle/>
                    <a:p>
                      <a:pPr algn="l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ev. + ONC201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2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2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1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2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1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914950269"/>
                  </a:ext>
                </a:extLst>
              </a:tr>
              <a:tr h="332544">
                <a:tc>
                  <a:txBody>
                    <a:bodyPr/>
                    <a:lstStyle/>
                    <a:p>
                      <a:pPr algn="l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ev. + ONC201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9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5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2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1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2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814793152"/>
                  </a:ext>
                </a:extLst>
              </a:tr>
              <a:tr h="332544">
                <a:tc>
                  <a:txBody>
                    <a:bodyPr/>
                    <a:lstStyle/>
                    <a:p>
                      <a:pPr algn="l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ev. + ONC201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5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6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9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1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2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492748671"/>
                  </a:ext>
                </a:extLst>
              </a:tr>
              <a:tr h="222460">
                <a:tc>
                  <a:txBody>
                    <a:bodyPr/>
                    <a:lstStyle/>
                    <a:p>
                      <a:pPr algn="l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gorafenib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8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9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2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35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1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59227809"/>
                  </a:ext>
                </a:extLst>
              </a:tr>
              <a:tr h="222460">
                <a:tc>
                  <a:txBody>
                    <a:bodyPr/>
                    <a:lstStyle/>
                    <a:p>
                      <a:pPr algn="l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gorafenib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5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7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9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5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98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1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651360404"/>
                  </a:ext>
                </a:extLst>
              </a:tr>
              <a:tr h="222460">
                <a:tc>
                  <a:txBody>
                    <a:bodyPr/>
                    <a:lstStyle/>
                    <a:p>
                      <a:pPr algn="l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gorafenib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2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5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2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17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3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195457883"/>
                  </a:ext>
                </a:extLst>
              </a:tr>
              <a:tr h="442627">
                <a:tc>
                  <a:txBody>
                    <a:bodyPr/>
                    <a:lstStyle/>
                    <a:p>
                      <a:pPr algn="l" fontAlgn="b"/>
                      <a:r>
                        <a:rPr lang="en-US" sz="1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gor</a:t>
                      </a:r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. + ONC201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7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6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1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12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8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129122389"/>
                  </a:ext>
                </a:extLst>
              </a:tr>
              <a:tr h="442627">
                <a:tc>
                  <a:txBody>
                    <a:bodyPr/>
                    <a:lstStyle/>
                    <a:p>
                      <a:pPr algn="l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gor. + ONC201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9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2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3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5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5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665158311"/>
                  </a:ext>
                </a:extLst>
              </a:tr>
              <a:tr h="442627">
                <a:tc>
                  <a:txBody>
                    <a:bodyPr/>
                    <a:lstStyle/>
                    <a:p>
                      <a:pPr algn="l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gor. + ONC201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9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7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5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5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5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615447485"/>
                  </a:ext>
                </a:extLst>
              </a:tr>
              <a:tr h="222460">
                <a:tc>
                  <a:txBody>
                    <a:bodyPr/>
                    <a:lstStyle/>
                    <a:p>
                      <a:pPr algn="l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ange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.2-.8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0-160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5-222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-77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4-298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5-111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38942755"/>
                  </a:ext>
                </a:extLst>
              </a:tr>
              <a:tr h="222460">
                <a:tc gridSpan="3">
                  <a:txBody>
                    <a:bodyPr/>
                    <a:lstStyle/>
                    <a:p>
                      <a:pPr algn="l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ithin normal range</a:t>
                      </a:r>
                    </a:p>
                  </a:txBody>
                  <a:tcPr marL="2293" marR="2293" marT="2293" marB="0" anchor="b">
                    <a:lnL>
                      <a:noFill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00B050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113810693"/>
                  </a:ext>
                </a:extLst>
              </a:tr>
              <a:tr h="119257">
                <a:tc gridSpan="3">
                  <a:txBody>
                    <a:bodyPr/>
                    <a:lstStyle/>
                    <a:p>
                      <a:pPr algn="l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levated</a:t>
                      </a:r>
                    </a:p>
                  </a:txBody>
                  <a:tcPr marL="2293" marR="2293" marT="2293" marB="0" anchor="b">
                    <a:lnL>
                      <a:noFill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000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293" marR="2293" marT="2293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52449929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094025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43</TotalTime>
  <Words>229</Words>
  <Application>Microsoft Office PowerPoint</Application>
  <PresentationFormat>Letter Paper (8.5x11 in)</PresentationFormat>
  <Paragraphs>153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Sevilla, Hernando Jr.</cp:lastModifiedBy>
  <cp:revision>14</cp:revision>
  <dcterms:created xsi:type="dcterms:W3CDTF">2017-08-21T16:00:13Z</dcterms:created>
  <dcterms:modified xsi:type="dcterms:W3CDTF">2018-01-15T02:08:47Z</dcterms:modified>
</cp:coreProperties>
</file>